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DDFF"/>
    <a:srgbClr val="4FE6FF"/>
    <a:srgbClr val="003A5D"/>
    <a:srgbClr val="00B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54"/>
  </p:normalViewPr>
  <p:slideViewPr>
    <p:cSldViewPr snapToGrid="0" snapToObjects="1">
      <p:cViewPr varScale="1">
        <p:scale>
          <a:sx n="78" d="100"/>
          <a:sy n="78" d="100"/>
        </p:scale>
        <p:origin x="5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62" d="100"/>
          <a:sy n="62" d="100"/>
        </p:scale>
        <p:origin x="3154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88FD3E-1513-4922-836E-69C1F256584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979F9-6F6C-4B1C-8474-9809D7DAE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637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979F9-6F6C-4B1C-8474-9809D7DAE2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54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48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223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10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97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2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83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92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1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08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17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805A4-B662-294F-9DA1-5D9B91FD62B8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19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AB67B-F644-49E3-B9C9-2951F830C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581" y="0"/>
            <a:ext cx="11642838" cy="1137055"/>
          </a:xfrm>
        </p:spPr>
        <p:txBody>
          <a:bodyPr>
            <a:normAutofit/>
          </a:bodyPr>
          <a:lstStyle/>
          <a:p>
            <a:pPr algn="ctr"/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Minimally Invasive Coronary Artery Bypass Grafting in Patient with Chronic Tracheostoma: Alternative to Reduce Sternal Wound Complication Risk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4CF4FF-198F-4038-A94A-73E2DD96E73F}"/>
              </a:ext>
            </a:extLst>
          </p:cNvPr>
          <p:cNvGrpSpPr/>
          <p:nvPr/>
        </p:nvGrpSpPr>
        <p:grpSpPr>
          <a:xfrm>
            <a:off x="274581" y="1137055"/>
            <a:ext cx="11642838" cy="4453641"/>
            <a:chOff x="274581" y="1137055"/>
            <a:chExt cx="11642838" cy="4453641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A66F968-4A60-40CC-ABF8-1715250DD3A4}"/>
                </a:ext>
              </a:extLst>
            </p:cNvPr>
            <p:cNvSpPr/>
            <p:nvPr/>
          </p:nvSpPr>
          <p:spPr>
            <a:xfrm>
              <a:off x="274581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E REPORT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6-year-old male, comorbid,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rail patient with chronic tracheostoma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2BD41FA-277E-48C9-A86D-24E908BEAB43}"/>
                </a:ext>
              </a:extLst>
            </p:cNvPr>
            <p:cNvSpPr/>
            <p:nvPr/>
          </p:nvSpPr>
          <p:spPr>
            <a:xfrm>
              <a:off x="4155527" y="1137055"/>
              <a:ext cx="3880946" cy="4453641"/>
            </a:xfrm>
            <a:prstGeom prst="rect">
              <a:avLst/>
            </a:prstGeom>
            <a:solidFill>
              <a:srgbClr val="11DD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RVEN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nimally invasive coronary artery bypass grafting via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all anterior thoracotomy</a:t>
              </a:r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BDD0B3E-97C4-4961-85FC-17F984B231B4}"/>
                </a:ext>
              </a:extLst>
            </p:cNvPr>
            <p:cNvSpPr/>
            <p:nvPr/>
          </p:nvSpPr>
          <p:spPr>
            <a:xfrm>
              <a:off x="8036473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UTCOME</a:t>
              </a: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CS CABG can mitigate sternal complications and provide effective revascularization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1067D66-3B18-4C13-BE99-9FADBCAC927E}"/>
              </a:ext>
            </a:extLst>
          </p:cNvPr>
          <p:cNvGrpSpPr/>
          <p:nvPr/>
        </p:nvGrpSpPr>
        <p:grpSpPr>
          <a:xfrm>
            <a:off x="274581" y="5590696"/>
            <a:ext cx="11642838" cy="1267304"/>
            <a:chOff x="274581" y="5590696"/>
            <a:chExt cx="11642838" cy="126730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5C1BC0D-3D40-4F7D-9935-BB8BC885EA74}"/>
                </a:ext>
              </a:extLst>
            </p:cNvPr>
            <p:cNvSpPr txBox="1"/>
            <p:nvPr/>
          </p:nvSpPr>
          <p:spPr>
            <a:xfrm>
              <a:off x="3204022" y="6627168"/>
              <a:ext cx="57262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@Innovationsjour | Copyright © The Author(s) 2022. All rights reserved. Published by SAGE Publishing Inc.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300ED5C-CD19-4926-A571-D5CC9C00E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581" y="5590696"/>
              <a:ext cx="11642838" cy="103647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0A69DF-628C-48B0-9981-44EBE0D1E2AA}"/>
                </a:ext>
              </a:extLst>
            </p:cNvPr>
            <p:cNvSpPr txBox="1"/>
            <p:nvPr/>
          </p:nvSpPr>
          <p:spPr>
            <a:xfrm>
              <a:off x="4026773" y="6280919"/>
              <a:ext cx="4781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antsios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et al. </a:t>
              </a:r>
              <a:r>
                <a:rPr lang="en-US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novations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November/December 2022.</a:t>
              </a:r>
            </a:p>
          </p:txBody>
        </p:sp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360C3706-B780-33F8-14EF-DFDC80C6AA1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4416937" y="2173527"/>
            <a:ext cx="3366740" cy="225150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0B9D727-4D01-9EDD-1E29-1049E25E2E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32630" y="2173527"/>
            <a:ext cx="1688631" cy="2251508"/>
          </a:xfrm>
          <a:prstGeom prst="rect">
            <a:avLst/>
          </a:prstGeom>
        </p:spPr>
      </p:pic>
      <p:pic>
        <p:nvPicPr>
          <p:cNvPr id="10" name="Picture 9" descr="Icon&#10;&#10;Description automatically generated with low confidence">
            <a:extLst>
              <a:ext uri="{FF2B5EF4-FFF2-40B4-BE49-F238E27FC236}">
                <a16:creationId xmlns:a16="http://schemas.microsoft.com/office/drawing/2014/main" id="{C032E601-B228-40BC-2953-7FAB0F166F8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9339" y="2167892"/>
            <a:ext cx="3371429" cy="2257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556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87</Words>
  <Application>Microsoft Office PowerPoint</Application>
  <PresentationFormat>Widescreen</PresentationFormat>
  <Paragraphs>4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Minimally Invasive Coronary Artery Bypass Grafting in Patient with Chronic Tracheostoma: Alternative to Reduce Sternal Wound Complication Risk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Kiesel</dc:creator>
  <cp:lastModifiedBy>Sari D. Holmes, PhD</cp:lastModifiedBy>
  <cp:revision>16</cp:revision>
  <dcterms:created xsi:type="dcterms:W3CDTF">2019-04-26T22:59:25Z</dcterms:created>
  <dcterms:modified xsi:type="dcterms:W3CDTF">2022-10-24T21:31:23Z</dcterms:modified>
</cp:coreProperties>
</file>